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5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A0045F2-8FD0-9C06-D472-DC0F66C1EA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9D81F47-F6B4-007D-5496-CD8A0047EA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D24A41B-6B69-A280-0BC6-956FB6F4E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9FDD16B-9F32-9326-0798-ECBBD47E1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C4B8B88-9C8D-50C1-BD3D-2062806CD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1519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954A77-B69D-B707-F358-74961B8300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CA6A5FE-04D9-AC12-D225-1B171AF40E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70160FE-954D-8561-494F-4B94AF386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8499B05-D2DB-A85E-977C-60A100A40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83CBBAA-BE2B-E57C-5F92-6E0B92172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6186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0128B4B-EA06-DCB5-A908-AFB268CE8E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5281461-9DCC-ED22-B12A-E15EC9289A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54183E-7F8D-F021-16C8-5885AC311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C336097-6906-6E29-AB52-32FE76A4E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9FCEF48-0B01-242B-F630-B238C833EE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8296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78B3F23-F830-2855-83FC-2C3C8D1DFB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6BDE7E-81F0-953F-0226-2220112388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975FDEF-92BE-3B6A-D63D-C0F481D6B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127E3C-E015-27DB-221A-BDB0D9673B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0EAA7ED-B2D5-4360-9789-7CA9C1DF4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5410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732D7E-C613-CCA9-E025-4D4445195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B93F1F4-75F0-6E94-6867-ACB2511EBF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A93BE08-0DC7-567A-A279-6999730AF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AB13854-072E-18A9-9506-FDAA12CB3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0A5A9C8-E811-3988-C86E-16A7AB647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5776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ED62A3-61B1-3E9B-F366-216B816E27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955DADA-1D45-36B1-37ED-194ABA5384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852C7F2-35EB-61DF-8468-85CFA51243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3E29A44-FA4C-5005-F79F-874CC9AEC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2DC5D21-AFF3-495F-4E76-667E6068E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6561CA5-A206-1907-87D9-E6FE726C2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0043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4C95110-98FB-06EF-00D0-536F0F544B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94CABDB-39C1-B859-5EA0-2344F6BE7E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DA5EBD0-33BC-F284-DAEF-A48048BAE0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D752CAFD-EDCD-3682-E287-C4E9C9A96F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FDD24CAD-1A70-BE88-B0AE-EFAF427644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4C2BE73E-6ED9-2A61-0491-561C414F1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662F171C-BD25-6A25-7256-19A5BB7D2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52554E3-99A9-8159-4633-8FE677836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7773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27F5B21-1536-1748-DD95-2C6674C00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3FFAA4A-CA99-4135-E700-CCDD77933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5581976-0DCA-C85B-974D-F62305756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E11C92E-C85A-FAB6-2109-768DE92BD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9993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14C66A4-A5DA-267E-DE33-912F026AA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10E3857-C05F-52D6-F862-AB5D7E6F48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2AC8FFB-78DE-4C02-EC85-3059D01B9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6016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4464282-9F92-0D5E-C10A-6CCAE7FEA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842431B-AA6B-CF4E-4F22-97035B7926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3C47570-59ED-50B0-B2D2-97076B7A3D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E2B3608-8D7C-9211-7F14-79B5713CE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3AD7811-E76B-FF84-5EAA-AC07E955D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CF76299-7FFA-997B-72F1-DF9028845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5286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B2AB3F-50DA-E406-CBB2-CBBDDB0B92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12EF418B-01CF-2471-6A47-A4442C5070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AF21855-CC74-57CA-8A8A-183D2C4D5E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222C616-D478-F066-B037-08D1697C0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EE819AA-5E7F-D774-DC23-932A9EEB2E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46C2A2B-6C58-DD9D-6B1C-8E13AB357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4448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B18CE4D-1ECF-7594-C01B-91EFBDCF85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3D99D10-8106-22CC-6F67-9D9E49FEC1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5F95F08-4309-AEDF-3CAB-9C1355AFBB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898808-473C-42B2-8A95-8626FA11221D}" type="datetimeFigureOut">
              <a:rPr lang="fr-FR" smtClean="0"/>
              <a:t>24/07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2879AAB-A70B-CD79-2414-8414E969B8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E7923-9798-F1E7-D268-B744930B5C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F2F3E-FD90-4CB3-9100-86244FADB0A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6685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E6F6BF-C303-2E73-A410-3C38F71649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817C3974-87ED-8E5B-1B71-EEDFDDAFD8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8776" y="1304693"/>
            <a:ext cx="4919051" cy="325414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FF24E619-F6C3-9E77-A55C-FB7647713785}"/>
              </a:ext>
            </a:extLst>
          </p:cNvPr>
          <p:cNvSpPr txBox="1"/>
          <p:nvPr/>
        </p:nvSpPr>
        <p:spPr>
          <a:xfrm>
            <a:off x="3070302" y="4840512"/>
            <a:ext cx="6096000" cy="4788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4 Fig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stability in the two components of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LS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DA analysis. Only genes above the 70% threshold were used for enrichment.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09666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5</Words>
  <Application>Microsoft Macintosh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oran Riazi</dc:creator>
  <cp:lastModifiedBy>Microsoft Office User</cp:lastModifiedBy>
  <cp:revision>4</cp:revision>
  <dcterms:created xsi:type="dcterms:W3CDTF">2024-02-27T13:56:55Z</dcterms:created>
  <dcterms:modified xsi:type="dcterms:W3CDTF">2024-07-24T09:35:30Z</dcterms:modified>
</cp:coreProperties>
</file>